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772400" cy="10058400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20016" autoAdjust="0"/>
    <p:restoredTop sz="96187" autoAdjust="0"/>
  </p:normalViewPr>
  <p:slideViewPr>
    <p:cSldViewPr snapToGrid="0">
      <p:cViewPr varScale="1">
        <p:scale>
          <a:sx n="71" d="100"/>
          <a:sy n="71" d="100"/>
        </p:scale>
        <p:origin x="1872" y="60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ebrowne\AppData\Local\Microsoft\Windows\Temporary%20Internet%20Files\Content.Outlook\3FLY2TO0\6-19-15_Aza-Adhesion_TACSTD2-ps2-Beta%20acti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ebrowne\AppData\Local\Microsoft\Windows\Temporary%20Internet%20Files\Content.Outlook\3FLY2TO0\6-19-15_Aza-Adhesion_TACSTD2-ps2-Beta%20acti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C</a:t>
            </a:r>
            <a:r>
              <a:rPr lang="en-US" baseline="-25000" dirty="0" smtClean="0"/>
              <a:t>t</a:t>
            </a:r>
            <a:r>
              <a:rPr lang="en-US" dirty="0" smtClean="0"/>
              <a:t> </a:t>
            </a:r>
            <a:r>
              <a:rPr lang="el-GR" dirty="0"/>
              <a:t>β</a:t>
            </a:r>
            <a:r>
              <a:rPr lang="en-US" dirty="0"/>
              <a:t>-actin Experiment 1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6-19-15_Aza-Adhesion_TACSTD2-ps2-Beta actin.xlsx]Sheet2'!$F$15</c:f>
              <c:strCache>
                <c:ptCount val="1"/>
                <c:pt idx="0">
                  <c:v>C(t) B-acti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6-19-15_Aza-Adhesion_TACSTD2-ps2-Beta actin.xlsx]Sheet2'!$E$16:$E$21</c:f>
              <c:strCache>
                <c:ptCount val="6"/>
                <c:pt idx="0">
                  <c:v>MCF7 control</c:v>
                </c:pt>
                <c:pt idx="1">
                  <c:v>MCF-7 +48hr 5-aza</c:v>
                </c:pt>
                <c:pt idx="2">
                  <c:v>MCF-7 +78hr 5-aza</c:v>
                </c:pt>
                <c:pt idx="3">
                  <c:v>TMX2-28 control</c:v>
                </c:pt>
                <c:pt idx="4">
                  <c:v>TMX2-28 +48 hr 5-aza</c:v>
                </c:pt>
                <c:pt idx="5">
                  <c:v>TMX2-28 +72 hr 5-aza</c:v>
                </c:pt>
              </c:strCache>
            </c:strRef>
          </c:cat>
          <c:val>
            <c:numRef>
              <c:f>'[6-19-15_Aza-Adhesion_TACSTD2-ps2-Beta actin.xlsx]Sheet2'!$F$16:$F$21</c:f>
              <c:numCache>
                <c:formatCode>General</c:formatCode>
                <c:ptCount val="6"/>
                <c:pt idx="0">
                  <c:v>21.664999999999999</c:v>
                </c:pt>
                <c:pt idx="1">
                  <c:v>20.925000000000001</c:v>
                </c:pt>
                <c:pt idx="2">
                  <c:v>21.015000000000001</c:v>
                </c:pt>
                <c:pt idx="3">
                  <c:v>21.21</c:v>
                </c:pt>
                <c:pt idx="4">
                  <c:v>21.17</c:v>
                </c:pt>
                <c:pt idx="5">
                  <c:v>21.1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1166880"/>
        <c:axId val="211167272"/>
      </c:barChart>
      <c:catAx>
        <c:axId val="2111668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Cell line and </a:t>
                </a:r>
                <a:r>
                  <a:rPr lang="en-US" dirty="0" smtClean="0"/>
                  <a:t>5-Aza-dC </a:t>
                </a:r>
                <a:r>
                  <a:rPr lang="en-US" dirty="0"/>
                  <a:t>treatment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167272"/>
        <c:crosses val="autoZero"/>
        <c:auto val="1"/>
        <c:lblAlgn val="ctr"/>
        <c:lblOffset val="100"/>
        <c:noMultiLvlLbl val="0"/>
      </c:catAx>
      <c:valAx>
        <c:axId val="211167272"/>
        <c:scaling>
          <c:orientation val="minMax"/>
          <c:max val="30"/>
          <c:min val="18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C</a:t>
                </a:r>
                <a:r>
                  <a:rPr lang="en-US" baseline="-25000" dirty="0" smtClean="0"/>
                  <a:t>t</a:t>
                </a:r>
                <a:endParaRPr lang="en-US" baseline="-250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1668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C</a:t>
            </a:r>
            <a:r>
              <a:rPr lang="en-US" baseline="-25000" dirty="0" smtClean="0"/>
              <a:t>t</a:t>
            </a:r>
            <a:r>
              <a:rPr lang="en-US" dirty="0" smtClean="0"/>
              <a:t> </a:t>
            </a:r>
            <a:r>
              <a:rPr lang="el-GR" sz="1400" b="0" i="0" u="none" strike="noStrike" baseline="0" dirty="0" smtClean="0">
                <a:effectLst/>
              </a:rPr>
              <a:t>β</a:t>
            </a:r>
            <a:r>
              <a:rPr lang="en-US" dirty="0"/>
              <a:t>-actin Experiment 2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6-19-15_Aza-Adhesion_TACSTD2-ps2-Beta actin.xlsx]Sheet2'!$F$23</c:f>
              <c:strCache>
                <c:ptCount val="1"/>
                <c:pt idx="0">
                  <c:v>C(t) B-acti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6-19-15_Aza-Adhesion_TACSTD2-ps2-Beta actin.xlsx]Sheet2'!$E$24:$E$29</c:f>
              <c:strCache>
                <c:ptCount val="6"/>
                <c:pt idx="0">
                  <c:v>MCF7 control</c:v>
                </c:pt>
                <c:pt idx="1">
                  <c:v>MCF-7 +48hr 5-aza</c:v>
                </c:pt>
                <c:pt idx="2">
                  <c:v>MCF-7 +78hr 5-aza</c:v>
                </c:pt>
                <c:pt idx="3">
                  <c:v>TMX2-28 control</c:v>
                </c:pt>
                <c:pt idx="4">
                  <c:v>TMX2-28 +48 hr 5-aza</c:v>
                </c:pt>
                <c:pt idx="5">
                  <c:v>TMX2-28 +72 hr 5-aza</c:v>
                </c:pt>
              </c:strCache>
            </c:strRef>
          </c:cat>
          <c:val>
            <c:numRef>
              <c:f>'[6-19-15_Aza-Adhesion_TACSTD2-ps2-Beta actin.xlsx]Sheet2'!$F$24:$F$29</c:f>
              <c:numCache>
                <c:formatCode>General</c:formatCode>
                <c:ptCount val="6"/>
                <c:pt idx="0">
                  <c:v>27.045000000000002</c:v>
                </c:pt>
                <c:pt idx="1">
                  <c:v>26.92</c:v>
                </c:pt>
                <c:pt idx="2">
                  <c:v>26.48</c:v>
                </c:pt>
                <c:pt idx="3">
                  <c:v>26.81</c:v>
                </c:pt>
                <c:pt idx="4">
                  <c:v>26.555</c:v>
                </c:pt>
                <c:pt idx="5">
                  <c:v>26.2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1166488"/>
        <c:axId val="211165704"/>
      </c:barChart>
      <c:catAx>
        <c:axId val="2111664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Cell</a:t>
                </a:r>
                <a:r>
                  <a:rPr lang="en-US" baseline="0" dirty="0"/>
                  <a:t> Line and </a:t>
                </a:r>
                <a:r>
                  <a:rPr lang="en-US" baseline="0" dirty="0" smtClean="0"/>
                  <a:t>5-Aza-dC </a:t>
                </a:r>
                <a:r>
                  <a:rPr lang="en-US" baseline="0" dirty="0"/>
                  <a:t>treatment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165704"/>
        <c:crosses val="autoZero"/>
        <c:auto val="1"/>
        <c:lblAlgn val="ctr"/>
        <c:lblOffset val="100"/>
        <c:noMultiLvlLbl val="0"/>
      </c:catAx>
      <c:valAx>
        <c:axId val="211165704"/>
        <c:scaling>
          <c:orientation val="minMax"/>
          <c:max val="30"/>
          <c:min val="18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C</a:t>
                </a:r>
                <a:r>
                  <a:rPr lang="en-US" baseline="-25000" dirty="0" smtClean="0"/>
                  <a:t>t</a:t>
                </a:r>
                <a:endParaRPr lang="en-US" baseline="-250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1664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C2503-24E7-4983-9021-94331A8E5FB8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0F0B-0936-470F-813C-B17A9CC61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0706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C2503-24E7-4983-9021-94331A8E5FB8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0F0B-0936-470F-813C-B17A9CC61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036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C2503-24E7-4983-9021-94331A8E5FB8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0F0B-0936-470F-813C-B17A9CC61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816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C2503-24E7-4983-9021-94331A8E5FB8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0F0B-0936-470F-813C-B17A9CC61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66778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C2503-24E7-4983-9021-94331A8E5FB8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0F0B-0936-470F-813C-B17A9CC61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781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C2503-24E7-4983-9021-94331A8E5FB8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0F0B-0936-470F-813C-B17A9CC61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42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C2503-24E7-4983-9021-94331A8E5FB8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0F0B-0936-470F-813C-B17A9CC61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323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C2503-24E7-4983-9021-94331A8E5FB8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0F0B-0936-470F-813C-B17A9CC61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7175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C2503-24E7-4983-9021-94331A8E5FB8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0F0B-0936-470F-813C-B17A9CC61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493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C2503-24E7-4983-9021-94331A8E5FB8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0F0B-0936-470F-813C-B17A9CC61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3398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C2503-24E7-4983-9021-94331A8E5FB8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0F0B-0936-470F-813C-B17A9CC61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3308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1C2503-24E7-4983-9021-94331A8E5FB8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4C0F0B-0936-470F-813C-B17A9CC61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145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08070"/>
              </p:ext>
            </p:extLst>
          </p:nvPr>
        </p:nvGraphicFramePr>
        <p:xfrm>
          <a:off x="1335156" y="210376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8951478"/>
              </p:ext>
            </p:extLst>
          </p:nvPr>
        </p:nvGraphicFramePr>
        <p:xfrm>
          <a:off x="1335156" y="506233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1051867" y="8236259"/>
            <a:ext cx="56651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Cambria" panose="02040503050406030204" pitchFamily="18" charset="0"/>
              </a:rPr>
              <a:t>Additional file 7: Figure </a:t>
            </a:r>
            <a:r>
              <a:rPr lang="en-US" sz="1200" b="1" dirty="0" smtClean="0">
                <a:latin typeface="Cambria" panose="02040503050406030204" pitchFamily="18" charset="0"/>
              </a:rPr>
              <a:t>S3. </a:t>
            </a:r>
            <a:r>
              <a:rPr lang="en-US" sz="1200" dirty="0" smtClean="0">
                <a:latin typeface="Cambria" panose="02040503050406030204" pitchFamily="18" charset="0"/>
              </a:rPr>
              <a:t> Raw C</a:t>
            </a:r>
            <a:r>
              <a:rPr lang="en-US" sz="1200" baseline="-25000" dirty="0" smtClean="0">
                <a:latin typeface="Cambria" panose="02040503050406030204" pitchFamily="18" charset="0"/>
              </a:rPr>
              <a:t>t</a:t>
            </a:r>
            <a:r>
              <a:rPr lang="en-US" sz="1200" dirty="0" smtClean="0">
                <a:latin typeface="Cambria" panose="02040503050406030204" pitchFamily="18" charset="0"/>
              </a:rPr>
              <a:t> values for </a:t>
            </a:r>
            <a:r>
              <a:rPr lang="el-GR" sz="1200" dirty="0" smtClean="0">
                <a:latin typeface="Cambria" panose="02040503050406030204" pitchFamily="18" charset="0"/>
              </a:rPr>
              <a:t>β</a:t>
            </a:r>
            <a:r>
              <a:rPr lang="en-US" sz="1200" dirty="0" smtClean="0">
                <a:latin typeface="Cambria" panose="02040503050406030204" pitchFamily="18" charset="0"/>
              </a:rPr>
              <a:t>-actin  RT-qPCR using two different cell lines (MCF7 and TMX2-28) and different lengths of 5-Aza-dC treatment (5-aza). </a:t>
            </a:r>
            <a:endParaRPr lang="en-US" sz="1200" b="1" dirty="0">
              <a:latin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7254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7</TotalTime>
  <Words>55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</vt:lpstr>
      <vt:lpstr>Office Theme</vt:lpstr>
      <vt:lpstr>PowerPoint Presentation</vt:lpstr>
    </vt:vector>
  </TitlesOfParts>
  <Company>University of Massachusett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va Browne</dc:creator>
  <cp:lastModifiedBy>Eva Browne</cp:lastModifiedBy>
  <cp:revision>11</cp:revision>
  <cp:lastPrinted>2018-06-13T18:51:44Z</cp:lastPrinted>
  <dcterms:created xsi:type="dcterms:W3CDTF">2018-06-04T19:41:40Z</dcterms:created>
  <dcterms:modified xsi:type="dcterms:W3CDTF">2018-06-25T21:37:40Z</dcterms:modified>
</cp:coreProperties>
</file>